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6" r:id="rId2"/>
    <p:sldId id="257" r:id="rId3"/>
    <p:sldId id="258" r:id="rId4"/>
    <p:sldId id="259" r:id="rId5"/>
    <p:sldId id="260" r:id="rId6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803" autoAdjust="0"/>
    <p:restoredTop sz="94660"/>
  </p:normalViewPr>
  <p:slideViewPr>
    <p:cSldViewPr snapToGrid="0">
      <p:cViewPr varScale="1">
        <p:scale>
          <a:sx n="86" d="100"/>
          <a:sy n="86" d="100"/>
        </p:scale>
        <p:origin x="1277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23B397-83E2-46A3-8CEB-33FA4909AC1A}" type="datetimeFigureOut">
              <a:rPr lang="fr-FR" smtClean="0"/>
              <a:t>15/01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2FDD87-3F50-47FB-9569-FA5311B821E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522146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23B397-83E2-46A3-8CEB-33FA4909AC1A}" type="datetimeFigureOut">
              <a:rPr lang="fr-FR" smtClean="0"/>
              <a:t>15/01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2FDD87-3F50-47FB-9569-FA5311B821E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326303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23B397-83E2-46A3-8CEB-33FA4909AC1A}" type="datetimeFigureOut">
              <a:rPr lang="fr-FR" smtClean="0"/>
              <a:t>15/01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2FDD87-3F50-47FB-9569-FA5311B821E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001071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23B397-83E2-46A3-8CEB-33FA4909AC1A}" type="datetimeFigureOut">
              <a:rPr lang="fr-FR" smtClean="0"/>
              <a:t>15/01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2FDD87-3F50-47FB-9569-FA5311B821E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630321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23B397-83E2-46A3-8CEB-33FA4909AC1A}" type="datetimeFigureOut">
              <a:rPr lang="fr-FR" smtClean="0"/>
              <a:t>15/01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2FDD87-3F50-47FB-9569-FA5311B821E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902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23B397-83E2-46A3-8CEB-33FA4909AC1A}" type="datetimeFigureOut">
              <a:rPr lang="fr-FR" smtClean="0"/>
              <a:t>15/01/2022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2FDD87-3F50-47FB-9569-FA5311B821E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490430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23B397-83E2-46A3-8CEB-33FA4909AC1A}" type="datetimeFigureOut">
              <a:rPr lang="fr-FR" smtClean="0"/>
              <a:t>15/01/2022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2FDD87-3F50-47FB-9569-FA5311B821E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920651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23B397-83E2-46A3-8CEB-33FA4909AC1A}" type="datetimeFigureOut">
              <a:rPr lang="fr-FR" smtClean="0"/>
              <a:t>15/01/2022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2FDD87-3F50-47FB-9569-FA5311B821E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64162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23B397-83E2-46A3-8CEB-33FA4909AC1A}" type="datetimeFigureOut">
              <a:rPr lang="fr-FR" smtClean="0"/>
              <a:t>15/01/2022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2FDD87-3F50-47FB-9569-FA5311B821E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226046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23B397-83E2-46A3-8CEB-33FA4909AC1A}" type="datetimeFigureOut">
              <a:rPr lang="fr-FR" smtClean="0"/>
              <a:t>15/01/2022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2FDD87-3F50-47FB-9569-FA5311B821E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132786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23B397-83E2-46A3-8CEB-33FA4909AC1A}" type="datetimeFigureOut">
              <a:rPr lang="fr-FR" smtClean="0"/>
              <a:t>15/01/2022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2FDD87-3F50-47FB-9569-FA5311B821E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628750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523B397-83E2-46A3-8CEB-33FA4909AC1A}" type="datetimeFigureOut">
              <a:rPr lang="fr-FR" smtClean="0"/>
              <a:t>15/01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2FDD87-3F50-47FB-9569-FA5311B821E8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970234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.png"/><Relationship Id="rId3" Type="http://schemas.openxmlformats.org/officeDocument/2006/relationships/image" Target="../media/image11.png"/><Relationship Id="rId7" Type="http://schemas.openxmlformats.org/officeDocument/2006/relationships/image" Target="../media/image15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4.png"/><Relationship Id="rId5" Type="http://schemas.openxmlformats.org/officeDocument/2006/relationships/image" Target="../media/image13.png"/><Relationship Id="rId10" Type="http://schemas.openxmlformats.org/officeDocument/2006/relationships/image" Target="../media/image18.png"/><Relationship Id="rId4" Type="http://schemas.openxmlformats.org/officeDocument/2006/relationships/image" Target="../media/image12.png"/><Relationship Id="rId9" Type="http://schemas.openxmlformats.org/officeDocument/2006/relationships/image" Target="../media/image17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5.png"/><Relationship Id="rId3" Type="http://schemas.openxmlformats.org/officeDocument/2006/relationships/image" Target="../media/image20.png"/><Relationship Id="rId7" Type="http://schemas.openxmlformats.org/officeDocument/2006/relationships/image" Target="../media/image24.png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3.png"/><Relationship Id="rId5" Type="http://schemas.openxmlformats.org/officeDocument/2006/relationships/image" Target="../media/image22.png"/><Relationship Id="rId10" Type="http://schemas.openxmlformats.org/officeDocument/2006/relationships/image" Target="../media/image27.png"/><Relationship Id="rId4" Type="http://schemas.openxmlformats.org/officeDocument/2006/relationships/image" Target="../media/image21.png"/><Relationship Id="rId9" Type="http://schemas.openxmlformats.org/officeDocument/2006/relationships/image" Target="../media/image26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34.png"/><Relationship Id="rId3" Type="http://schemas.openxmlformats.org/officeDocument/2006/relationships/image" Target="../media/image29.png"/><Relationship Id="rId7" Type="http://schemas.openxmlformats.org/officeDocument/2006/relationships/image" Target="../media/image33.png"/><Relationship Id="rId2" Type="http://schemas.openxmlformats.org/officeDocument/2006/relationships/image" Target="../media/image2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2.png"/><Relationship Id="rId5" Type="http://schemas.openxmlformats.org/officeDocument/2006/relationships/image" Target="../media/image31.png"/><Relationship Id="rId10" Type="http://schemas.openxmlformats.org/officeDocument/2006/relationships/image" Target="../media/image36.png"/><Relationship Id="rId4" Type="http://schemas.openxmlformats.org/officeDocument/2006/relationships/image" Target="../media/image30.png"/><Relationship Id="rId9" Type="http://schemas.openxmlformats.org/officeDocument/2006/relationships/image" Target="../media/image35.png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37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Image 12">
            <a:extLst>
              <a:ext uri="{FF2B5EF4-FFF2-40B4-BE49-F238E27FC236}">
                <a16:creationId xmlns:a16="http://schemas.microsoft.com/office/drawing/2014/main" id="{625A98D2-504B-43D0-8EE7-FEE9654A4DF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582926" y="-7423"/>
            <a:ext cx="3323074" cy="2160000"/>
          </a:xfrm>
          <a:prstGeom prst="rect">
            <a:avLst/>
          </a:prstGeom>
        </p:spPr>
      </p:pic>
      <p:pic>
        <p:nvPicPr>
          <p:cNvPr id="14" name="Picture 2" descr="FeatureImage">
            <a:extLst>
              <a:ext uri="{FF2B5EF4-FFF2-40B4-BE49-F238E27FC236}">
                <a16:creationId xmlns:a16="http://schemas.microsoft.com/office/drawing/2014/main" id="{DA0A4CB3-5FAC-46B9-9EC7-A097CCFCE95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-7746" y="-7423"/>
            <a:ext cx="3323074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5" name="Picture 4" descr="FeatureImage">
            <a:extLst>
              <a:ext uri="{FF2B5EF4-FFF2-40B4-BE49-F238E27FC236}">
                <a16:creationId xmlns:a16="http://schemas.microsoft.com/office/drawing/2014/main" id="{89DE3069-FBED-4CAC-AED7-AACEE22CE0C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23075" y="0"/>
            <a:ext cx="3323074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6" name="Picture 6" descr="FeatureImage">
            <a:extLst>
              <a:ext uri="{FF2B5EF4-FFF2-40B4-BE49-F238E27FC236}">
                <a16:creationId xmlns:a16="http://schemas.microsoft.com/office/drawing/2014/main" id="{A58E8770-643B-484D-9A0E-01073F7030E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2230958"/>
            <a:ext cx="3323077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7" name="Picture 8" descr="FeatureImage">
            <a:extLst>
              <a:ext uri="{FF2B5EF4-FFF2-40B4-BE49-F238E27FC236}">
                <a16:creationId xmlns:a16="http://schemas.microsoft.com/office/drawing/2014/main" id="{E5D85619-6E81-4729-9518-8ADF08F1B1F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91463" y="2248715"/>
            <a:ext cx="3323077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8" name="Picture 10" descr="FeatureImage">
            <a:extLst>
              <a:ext uri="{FF2B5EF4-FFF2-40B4-BE49-F238E27FC236}">
                <a16:creationId xmlns:a16="http://schemas.microsoft.com/office/drawing/2014/main" id="{424E82F1-F99E-4B30-953F-668FCC06DA1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614540" y="2248720"/>
            <a:ext cx="3323077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6" name="Picture 12" descr="FeatureImage">
            <a:extLst>
              <a:ext uri="{FF2B5EF4-FFF2-40B4-BE49-F238E27FC236}">
                <a16:creationId xmlns:a16="http://schemas.microsoft.com/office/drawing/2014/main" id="{CD22E85A-DA8E-4788-A70D-39BD88ABE125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4594726"/>
            <a:ext cx="3323077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8" name="Picture 14" descr="FeatureImage">
            <a:extLst>
              <a:ext uri="{FF2B5EF4-FFF2-40B4-BE49-F238E27FC236}">
                <a16:creationId xmlns:a16="http://schemas.microsoft.com/office/drawing/2014/main" id="{F1F26CE3-4AD9-4C51-ADF5-23080284AC7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91461" y="4594726"/>
            <a:ext cx="3323077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40" name="Picture 16" descr="FeatureImage">
            <a:extLst>
              <a:ext uri="{FF2B5EF4-FFF2-40B4-BE49-F238E27FC236}">
                <a16:creationId xmlns:a16="http://schemas.microsoft.com/office/drawing/2014/main" id="{D6980382-6002-4334-8A38-9FDB8C5D6FC6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646149" y="4594726"/>
            <a:ext cx="3323077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56347659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 descr="FeatureImage">
            <a:extLst>
              <a:ext uri="{FF2B5EF4-FFF2-40B4-BE49-F238E27FC236}">
                <a16:creationId xmlns:a16="http://schemas.microsoft.com/office/drawing/2014/main" id="{3EF21933-5EAE-434D-B3BC-965D9A88E49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" y="78921"/>
            <a:ext cx="3323077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2" name="Picture 4" descr="FeatureImage">
            <a:extLst>
              <a:ext uri="{FF2B5EF4-FFF2-40B4-BE49-F238E27FC236}">
                <a16:creationId xmlns:a16="http://schemas.microsoft.com/office/drawing/2014/main" id="{C52DEF2C-5294-434C-B236-9816BA86F66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91461" y="78921"/>
            <a:ext cx="3323077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4" name="Picture 6" descr="FeatureImage">
            <a:extLst>
              <a:ext uri="{FF2B5EF4-FFF2-40B4-BE49-F238E27FC236}">
                <a16:creationId xmlns:a16="http://schemas.microsoft.com/office/drawing/2014/main" id="{E4A10860-1B3C-41A9-BC49-62288EE92225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582923" y="78921"/>
            <a:ext cx="3323077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64" name="Picture 16" descr="FeatureImage">
            <a:extLst>
              <a:ext uri="{FF2B5EF4-FFF2-40B4-BE49-F238E27FC236}">
                <a16:creationId xmlns:a16="http://schemas.microsoft.com/office/drawing/2014/main" id="{B075854F-B87E-4B9C-9D8E-63C91D43CD86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-5490" y="2238921"/>
            <a:ext cx="3323077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66" name="Picture 18" descr="FeatureImage">
            <a:extLst>
              <a:ext uri="{FF2B5EF4-FFF2-40B4-BE49-F238E27FC236}">
                <a16:creationId xmlns:a16="http://schemas.microsoft.com/office/drawing/2014/main" id="{FC6DC962-C7A5-4CA9-AE17-A643DE664CC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00168" y="2238921"/>
            <a:ext cx="3323077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" name="Picture 2" descr="FeatureImage">
            <a:extLst>
              <a:ext uri="{FF2B5EF4-FFF2-40B4-BE49-F238E27FC236}">
                <a16:creationId xmlns:a16="http://schemas.microsoft.com/office/drawing/2014/main" id="{0E1B28ED-D208-495B-9B7C-8DE1889DABE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605827" y="2238921"/>
            <a:ext cx="3323077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2" name="Picture 6" descr="FeatureImage">
            <a:extLst>
              <a:ext uri="{FF2B5EF4-FFF2-40B4-BE49-F238E27FC236}">
                <a16:creationId xmlns:a16="http://schemas.microsoft.com/office/drawing/2014/main" id="{D7829868-EAB3-4F80-BE6A-F7287AA2BF1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-13610" y="4554583"/>
            <a:ext cx="3323077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68" name="Picture 20" descr="FeatureImage">
            <a:extLst>
              <a:ext uri="{FF2B5EF4-FFF2-40B4-BE49-F238E27FC236}">
                <a16:creationId xmlns:a16="http://schemas.microsoft.com/office/drawing/2014/main" id="{8D1A1FE1-DA64-4CF0-BBAA-44B64EC9EE25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83340" y="4563292"/>
            <a:ext cx="3323077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70" name="Picture 22" descr="FeatureImage">
            <a:extLst>
              <a:ext uri="{FF2B5EF4-FFF2-40B4-BE49-F238E27FC236}">
                <a16:creationId xmlns:a16="http://schemas.microsoft.com/office/drawing/2014/main" id="{1BC8AB06-6A96-43FC-A191-CF196539D1A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597708" y="4563292"/>
            <a:ext cx="3323077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08487984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82" name="Picture 10" descr="FeatureImage">
            <a:extLst>
              <a:ext uri="{FF2B5EF4-FFF2-40B4-BE49-F238E27FC236}">
                <a16:creationId xmlns:a16="http://schemas.microsoft.com/office/drawing/2014/main" id="{7E88F2D2-7BEC-4FF1-B7BC-1FC0809DEBA4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-26126" y="33806"/>
            <a:ext cx="3323077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84" name="Picture 12" descr="FeatureImage">
            <a:extLst>
              <a:ext uri="{FF2B5EF4-FFF2-40B4-BE49-F238E27FC236}">
                <a16:creationId xmlns:a16="http://schemas.microsoft.com/office/drawing/2014/main" id="{B35EF3D5-F323-4C54-A7EE-47E557B66F7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88242" y="33806"/>
            <a:ext cx="3323077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86" name="Picture 14" descr="FeatureImage">
            <a:extLst>
              <a:ext uri="{FF2B5EF4-FFF2-40B4-BE49-F238E27FC236}">
                <a16:creationId xmlns:a16="http://schemas.microsoft.com/office/drawing/2014/main" id="{05F1ABFB-1552-456E-B721-176459411D6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574214" y="52854"/>
            <a:ext cx="3323077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88" name="Picture 16" descr="FeatureImage">
            <a:extLst>
              <a:ext uri="{FF2B5EF4-FFF2-40B4-BE49-F238E27FC236}">
                <a16:creationId xmlns:a16="http://schemas.microsoft.com/office/drawing/2014/main" id="{21842360-059A-4E14-92DF-D0E9303B160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-10012" y="2314826"/>
            <a:ext cx="3323077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90" name="Picture 18" descr="FeatureImage">
            <a:extLst>
              <a:ext uri="{FF2B5EF4-FFF2-40B4-BE49-F238E27FC236}">
                <a16:creationId xmlns:a16="http://schemas.microsoft.com/office/drawing/2014/main" id="{E7CAE403-12EC-4659-9FFC-07DAC327655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77687" y="2345923"/>
            <a:ext cx="3323077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92" name="Picture 20" descr="FeatureImage">
            <a:extLst>
              <a:ext uri="{FF2B5EF4-FFF2-40B4-BE49-F238E27FC236}">
                <a16:creationId xmlns:a16="http://schemas.microsoft.com/office/drawing/2014/main" id="{C7E4BE8B-CE50-489D-8A5C-E464693CB89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585192" y="2345923"/>
            <a:ext cx="3323077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94" name="Picture 22" descr="FeatureImage">
            <a:extLst>
              <a:ext uri="{FF2B5EF4-FFF2-40B4-BE49-F238E27FC236}">
                <a16:creationId xmlns:a16="http://schemas.microsoft.com/office/drawing/2014/main" id="{CF64BEC6-0E96-4450-989C-01BC472DADA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-8709" y="4658040"/>
            <a:ext cx="3323077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96" name="Picture 24" descr="FeatureImage">
            <a:extLst>
              <a:ext uri="{FF2B5EF4-FFF2-40B4-BE49-F238E27FC236}">
                <a16:creationId xmlns:a16="http://schemas.microsoft.com/office/drawing/2014/main" id="{0A514954-83A6-4A38-8A8A-D587E4C3462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14368" y="4658040"/>
            <a:ext cx="3323077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098" name="Picture 26" descr="FeatureImage">
            <a:extLst>
              <a:ext uri="{FF2B5EF4-FFF2-40B4-BE49-F238E27FC236}">
                <a16:creationId xmlns:a16="http://schemas.microsoft.com/office/drawing/2014/main" id="{7562149C-2597-42AB-BF15-306EFD9D5F55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602610" y="4680582"/>
            <a:ext cx="3323077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86952482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4" descr="FeatureImage">
            <a:extLst>
              <a:ext uri="{FF2B5EF4-FFF2-40B4-BE49-F238E27FC236}">
                <a16:creationId xmlns:a16="http://schemas.microsoft.com/office/drawing/2014/main" id="{9A80E03B-5D6A-4D25-A4D2-4A25821F0FA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628736" y="2357709"/>
            <a:ext cx="3323077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" name="Picture 14" descr="FeatureImage">
            <a:extLst>
              <a:ext uri="{FF2B5EF4-FFF2-40B4-BE49-F238E27FC236}">
                <a16:creationId xmlns:a16="http://schemas.microsoft.com/office/drawing/2014/main" id="{17E01105-F568-4683-82F7-9909CDF25C86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4648858"/>
            <a:ext cx="3323077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" name="Picture 8" descr="FeatureImage">
            <a:extLst>
              <a:ext uri="{FF2B5EF4-FFF2-40B4-BE49-F238E27FC236}">
                <a16:creationId xmlns:a16="http://schemas.microsoft.com/office/drawing/2014/main" id="{D6806D0F-9EC0-40D1-8BCA-EB68EA51ACC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14368" y="2361062"/>
            <a:ext cx="3323077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098" name="Picture 2" descr="FeatureImage">
            <a:extLst>
              <a:ext uri="{FF2B5EF4-FFF2-40B4-BE49-F238E27FC236}">
                <a16:creationId xmlns:a16="http://schemas.microsoft.com/office/drawing/2014/main" id="{AB799AE1-6AF4-400D-B3AD-B7C8587F3F75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-52254" y="16970"/>
            <a:ext cx="3323077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00" name="Picture 4" descr="FeatureImage">
            <a:extLst>
              <a:ext uri="{FF2B5EF4-FFF2-40B4-BE49-F238E27FC236}">
                <a16:creationId xmlns:a16="http://schemas.microsoft.com/office/drawing/2014/main" id="{149CE675-943D-4A63-9A5D-0238ED03E0BE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62114" y="16970"/>
            <a:ext cx="3323077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02" name="Picture 6" descr="FeatureImage">
            <a:extLst>
              <a:ext uri="{FF2B5EF4-FFF2-40B4-BE49-F238E27FC236}">
                <a16:creationId xmlns:a16="http://schemas.microsoft.com/office/drawing/2014/main" id="{0D04087C-C354-45B9-A7C9-5823A4562D6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585191" y="29032"/>
            <a:ext cx="3323077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104" name="Picture 8" descr="FeatureImage">
            <a:extLst>
              <a:ext uri="{FF2B5EF4-FFF2-40B4-BE49-F238E27FC236}">
                <a16:creationId xmlns:a16="http://schemas.microsoft.com/office/drawing/2014/main" id="{2522CE16-F6D4-4E58-951F-43988B61785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2349000"/>
            <a:ext cx="3323077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2" name="Picture 10" descr="FeatureImage">
            <a:extLst>
              <a:ext uri="{FF2B5EF4-FFF2-40B4-BE49-F238E27FC236}">
                <a16:creationId xmlns:a16="http://schemas.microsoft.com/office/drawing/2014/main" id="{E021E90A-12F1-45AF-AD6D-E08B8FFC919E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551306" y="4640111"/>
            <a:ext cx="3323077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3" name="Picture 12" descr="FeatureImage">
            <a:extLst>
              <a:ext uri="{FF2B5EF4-FFF2-40B4-BE49-F238E27FC236}">
                <a16:creationId xmlns:a16="http://schemas.microsoft.com/office/drawing/2014/main" id="{8699F829-2E0C-493E-A3A5-01C2B2CA6F5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91461" y="4645505"/>
            <a:ext cx="3323077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66326916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8" descr="FeatureImage">
            <a:extLst>
              <a:ext uri="{FF2B5EF4-FFF2-40B4-BE49-F238E27FC236}">
                <a16:creationId xmlns:a16="http://schemas.microsoft.com/office/drawing/2014/main" id="{C4DD4D45-6571-477F-95A9-857953AAF74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2102" y="149623"/>
            <a:ext cx="3323077" cy="21600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ZoneTexte 2">
            <a:extLst>
              <a:ext uri="{FF2B5EF4-FFF2-40B4-BE49-F238E27FC236}">
                <a16:creationId xmlns:a16="http://schemas.microsoft.com/office/drawing/2014/main" id="{328B1D6E-0DEA-4E97-8194-4B2FA100FAB0}"/>
              </a:ext>
            </a:extLst>
          </p:cNvPr>
          <p:cNvSpPr txBox="1"/>
          <p:nvPr/>
        </p:nvSpPr>
        <p:spPr>
          <a:xfrm>
            <a:off x="277754" y="2637464"/>
            <a:ext cx="9211176" cy="12772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just"/>
            <a:r>
              <a:rPr lang="fr-FR" sz="1100" b="1" dirty="0"/>
              <a:t>Appendix 2: </a:t>
            </a:r>
            <a:r>
              <a:rPr lang="en-US" sz="1100" dirty="0"/>
              <a:t>Boxplots of concentrations of metabolites measured by GC-MS in food-deprived adults of the tenebrionid beetle </a:t>
            </a:r>
            <a:r>
              <a:rPr lang="en-US" sz="1100" i="1" dirty="0" err="1"/>
              <a:t>Alphitobius</a:t>
            </a:r>
            <a:r>
              <a:rPr lang="en-US" sz="1100" i="1" dirty="0"/>
              <a:t> </a:t>
            </a:r>
            <a:r>
              <a:rPr lang="en-US" sz="1100" i="1" dirty="0" err="1"/>
              <a:t>diaperinus</a:t>
            </a:r>
            <a:r>
              <a:rPr lang="en-US" sz="1100" dirty="0"/>
              <a:t>  exposed </a:t>
            </a:r>
          </a:p>
          <a:p>
            <a:pPr algn="just"/>
            <a:r>
              <a:rPr lang="en-US" sz="1100" dirty="0"/>
              <a:t>at 10 % RH (Desiccation, D) or 60 % RH (No desiccation, ND) for 1, 2, 3 or 5 weeks. </a:t>
            </a:r>
          </a:p>
          <a:p>
            <a:pPr algn="just"/>
            <a:r>
              <a:rPr lang="en-US" sz="1100" dirty="0"/>
              <a:t>Original concentrations are expressed in </a:t>
            </a:r>
            <a:r>
              <a:rPr lang="en-US" sz="1100" dirty="0" err="1"/>
              <a:t>nmoles</a:t>
            </a:r>
            <a:r>
              <a:rPr lang="en-US" sz="1100" dirty="0"/>
              <a:t>/mg dry mass</a:t>
            </a:r>
          </a:p>
          <a:p>
            <a:pPr algn="just"/>
            <a:r>
              <a:rPr lang="en-US" sz="1100" dirty="0"/>
              <a:t>Normalized concentrations: analyses (PCA) were performed on cube root-transformed metabolite concentrations that were additionally auto-scaled.</a:t>
            </a:r>
          </a:p>
          <a:p>
            <a:pPr algn="just"/>
            <a:endParaRPr lang="en-US" sz="1100" dirty="0"/>
          </a:p>
          <a:p>
            <a:pPr algn="just"/>
            <a:r>
              <a:rPr lang="en-US" sz="1100" dirty="0"/>
              <a:t>Metabolites are presented according to the loadings they had on PC1, starting with metabolites having the largest negative factor loadings in PC1, and ending</a:t>
            </a:r>
          </a:p>
          <a:p>
            <a:pPr algn="just"/>
            <a:r>
              <a:rPr lang="en-US" sz="1100" dirty="0"/>
              <a:t>with metabolites having the largest positive factor loadings in PC1.</a:t>
            </a:r>
          </a:p>
        </p:txBody>
      </p:sp>
    </p:spTree>
    <p:extLst>
      <p:ext uri="{BB962C8B-B14F-4D97-AF65-F5344CB8AC3E}">
        <p14:creationId xmlns:p14="http://schemas.microsoft.com/office/powerpoint/2010/main" val="3700897109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16</Words>
  <Application>Microsoft Office PowerPoint</Application>
  <PresentationFormat>Format A4 (210 x 297 mm)</PresentationFormat>
  <Paragraphs>7</Paragraphs>
  <Slides>5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Thème Office</vt:lpstr>
      <vt:lpstr>Présentation PowerPoint</vt:lpstr>
      <vt:lpstr>Présentation PowerPoint</vt:lpstr>
      <vt:lpstr>Présentation PowerPoint</vt:lpstr>
      <vt:lpstr>Présentation PowerPoint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RENAULT David</dc:creator>
  <cp:lastModifiedBy>RENAULT David</cp:lastModifiedBy>
  <cp:revision>17</cp:revision>
  <dcterms:created xsi:type="dcterms:W3CDTF">2022-01-10T15:35:38Z</dcterms:created>
  <dcterms:modified xsi:type="dcterms:W3CDTF">2022-01-15T10:32:08Z</dcterms:modified>
</cp:coreProperties>
</file>